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9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32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83AA79C-3874-BCFC-4841-A0BC72A67C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6061753-DCCC-00B5-10F6-BE4E9FFED6C1}"/>
              </a:ext>
            </a:extLst>
          </p:cNvPr>
          <p:cNvSpPr txBox="1"/>
          <p:nvPr/>
        </p:nvSpPr>
        <p:spPr>
          <a:xfrm>
            <a:off x="874350" y="1852227"/>
            <a:ext cx="14615198" cy="174509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2000" b="1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###GD model, single-locus HEG, with sex-specific homing and maternal deposition, neutral gene drive blocking indels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function (cM = 1, cF = 1, dF = 0, chM = 0, crM = 0, chF = 0, 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      crF = 0, dhF = 0, drF = 0, eta = NULL, phi = NULL, omega = NULL, </a:t>
            </a:r>
          </a:p>
          <a:p>
            <a:pPr marL="0" marR="0"/>
            <a:r>
              <a:rPr lang="it-IT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      xiF = NULL, xiM = NULL, s = NULL) 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{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if (any(c(cM, cF, dF, chM, crM, chF, crF, dhF, drF) &gt; 1) || 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    any(c(cM, cF, dF, chM, crM, chF, crF, dhF, drF) &lt; 0)) {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    stop("Parameters are rates, they must be between 0 and 1."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}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gtype &lt;- c("WW", "WH", "WR", "HH", "HR", "RR"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size &lt;- length(gtype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 &lt;- array(data = 0, dim = c(size, size, size), dimnames = list(gtype,    gtype, gtype)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# B allele is removed from the model</a:t>
            </a: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('WW', 'WH', 'WR', 'HH', 'HR', 'RR')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W','WW', 'WW'] &lt;- 1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R','WW', c('WW', 'WR')] &lt;- c( 1,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R','WR', c('WW', 'WR', 'RR')] &lt;- c( 1/2, 1, 1/2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H','HH', 'HH'] &lt;- 1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R','HH', c('HH', 'HR')] &lt;- c( 1,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R','HR', c('HH', 'HR', 'RR')] &lt;- c( 1/2, 1, 1/2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RR','WW', 'WR'] &lt;- 1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RR','WR', c('WR', 'RR')] &lt;- c( 1,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RR','HH', 'HR'] &lt;- 1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es-ES_trad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RR','HR', c('HR', 'RR')] &lt;- c( 1,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RR','RR', 'RR'] &lt;- 1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# set the other half of the matrix that is symmetric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print(xiF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print(xiM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 Boolean matrix for subsetting, used several times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boolMat &lt;- upper.tri(x = tMatrix[ , ,1], diag = FALSE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 loop over depth, set upper triangle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for(z in 1:size){tMatrix[ , ,z][boolMat] &lt;- t(tMatrix[ , ,z])[boolMat]}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# fill asymmetric parts of tMatrix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female specific homing, except for WHxWH</a:t>
            </a:r>
          </a:p>
          <a:p>
            <a:pPr marL="0" marR="0"/>
            <a:r>
              <a:rPr lang="nl-NL" sz="1600" b="1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H','WW', ] &lt;- c((1-cF)*(1-dF), (1+cF*chF)*(1-dF), (1-cF</a:t>
            </a:r>
            <a:r>
              <a:rPr lang="en-US" sz="1600" b="1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*chF)*dF*drF + (cF*crF)*(1-dF),  (1+cF*chF)*dF*dhF, (1+cF*chF)*dF*(1-dhF)*drF, (cF*crF)*dF*drF)/2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H','WH', ] &lt;- c((1-cF)*(1-cM)*(1-dF), (1+cF*chF)*(1-cM)*(1-dF) + (1-cF)*(1+cM*chM),(1-cF*chF)*(1-cM)*dF*drF + cF*crF*(1-cM)*(1-dF) + (1-cF)*cM*crM,  (1+cF*chF)*(1-cM)*dF*dhF + (1+cF*chF)*(1+cM*chM), (1+cF*chF)*(1-cM)*dF*(1-dhF)*drF + cF*(1-chF)*crF*(1+cM*chM) + (1+cF*chF)*cM*(1-chM)*crM,  cF*crF*(1-cM)*dF*drF + cF*crF*cM*(1-chM)*crM)/4</a:t>
            </a: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H','WR', ] &lt;- c((1-cF)*(1-dF), (1+cF*chF)*(1-dF), (1-cF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*chF)*dF*drF + (cF*crF)*(1-dF) + 1-cF, (1+cF*chF)*dF*dhF, (1+cF*chF)*dF*(1-dhF)*drF + 1+cF*chF, cF*(1-chF)*dF*drF + cF*crF)/4</a:t>
            </a: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H','HH',c('WH', 'HH', 'HR')] &lt;- c(1-cF, 1+cF*chF, cF*crF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H','RR',c('WR', 'HR', 'RR')] &lt;- c(1-cF, 1+cF*chF 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, cF*crF )/2</a:t>
            </a: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H','HR',c('WH', 'HH', 'HR', 'WR', 'RR')] &lt;- c(1-cF, 1+cF*chF, cF*crF + 1+cF*chF, 1-cF, cF*(1-chF)*crF)/4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</a:t>
            </a:r>
          </a:p>
          <a:p>
            <a:pPr marL="0" marR="0"/>
            <a:r>
              <a:rPr lang="en-US" sz="1600" dirty="0">
                <a:solidFill>
                  <a:srgbClr val="000000"/>
                </a:solidFill>
                <a:ea typeface="Arial Unicode MS"/>
                <a:cs typeface="Arial Unicode MS"/>
              </a:rPr>
              <a:t>    </a:t>
            </a:r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tMatrix['HH','WW', c('WH', 'HH', 'HR')] &lt;- c( 1-dF, dF*dhF, dF*(1-dhF)*drF)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H','WR', c('WH', 'HH', 'HR')] &lt;- c( 1-dF, dF*dhF, dF*(1-dhF)*drF +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R','WW', c('WH', 'WR', 'HH', 'HR', 'RR')] &lt;- c( 1-dF, 1-dF, dF*dhF, dF*(1-dhF)*drF, dF*drF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R','WR', c('WH', 'WR', 'HH', 'HR', 'RR')] &lt;- c( 1-dF, 1-dF, dF*dhF, dF*(1-dhF)*drF + 1, dF*drF + 1)/4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#male specific homing, deposition effects from female ribonucleoprotein only for the HHxWH and </a:t>
            </a:r>
            <a:r>
              <a:rPr lang="en-US" sz="1600" dirty="0" err="1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HRxWH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crosses</a:t>
            </a:r>
          </a:p>
          <a:p>
            <a:pPr marL="0" marR="0"/>
            <a:r>
              <a:rPr lang="nl-NL" sz="1600" b="1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W','WH', c('WW', 'WH', 'WR')] &lt;- c(1-cM, 1+cM*chM, cM*crM)/2</a:t>
            </a:r>
            <a:endParaRPr lang="en-US" sz="1600" b="1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R','WH', c('WW', 'WH', 'WR', 'HR', 'RR')] &lt;- c(1-cM, 1+cM*chM, cM*crM + 1-cM, 1+cM*chM, cM*(1-chM)*crM)/4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H','WH', c('WH', 'HH', 'HR')] &lt;- c((1-cM)*(1-dF), 1+cM*chM + (1-cM)*dF*dhF, cM*crM + (1-cM)*dF*(1-dhF)*drF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RR','WH', c('WR', 'HR', 'RR')] &lt;- c(1-cM, 1+cM*chM, cM*crM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HR','WH', c('WH', '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WR</a:t>
            </a:r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', 'H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H</a:t>
            </a:r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', '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H</a:t>
            </a:r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R', 'RR')] &lt;- c((1-cM)*(1-dF), (1-cM)*(1-dF), 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1+cM*chM + (1-cM*chM)*dF*dhF, cM*(1-chM)*crM + 1+cM*chM + (1-cM)*dF*(1-dhF)*drF, cM*(1-chM)*crM + (1-cM)*dF*drF)/4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#no gene drive, no deposition effects (H allel</a:t>
            </a:r>
            <a:r>
              <a:rPr lang="en-US" sz="1600" dirty="0">
                <a:solidFill>
                  <a:srgbClr val="000000"/>
                </a:solidFill>
                <a:ea typeface="Arial Unicode MS"/>
                <a:cs typeface="Arial Unicode MS"/>
              </a:rPr>
              <a:t>e is </a:t>
            </a:r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from the male)</a:t>
            </a: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W','HH', 'WH'] &lt;- 1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R','HH', c('WH', 'HR')] &lt;- c( 1,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W','HR', c('WH', 'WR')] &lt;- c( 1, 1)/2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nl-NL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'WR','HR', c('WH', 'WR', 'HR', 'RR')] &lt;- c( 1, 1, 1, 1)/4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tMatrix[tMatrix &lt; .Machine$double.eps] &lt;- 0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viabilityMask &lt;- array(data = 1, dim = c(size, size, size), 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                       dimnames = list(gtype, gtype, gtype))</a:t>
            </a:r>
          </a:p>
          <a:p>
            <a:pPr marL="0" marR="0"/>
            <a:r>
              <a:rPr lang="fr-FR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modifiers = MGDrivE:::cubeModifiers(gtype, eta = eta, phi = phi, omega = omega, </a:t>
            </a:r>
            <a:endParaRPr lang="en-US" sz="1600" dirty="0">
              <a:ln>
                <a:noFill/>
              </a:ln>
              <a:solidFill>
                <a:srgbClr val="000000"/>
              </a:solidFill>
              <a:effectLst/>
              <a:ea typeface="Arial Unicode MS"/>
              <a:cs typeface="Arial Unicode MS"/>
            </a:endParaRP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                          xiF = xiF, xiM = xiM, s = s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    return(list(ih = tMatrix, tau = viabilityMask, genotypesID = gtype, genotypesN = size, wildType = "WW", eta = modifiers$eta, phi = modifiers$phi, omega = modifiers$omega, xiF = modifiers$xiF, xiM = modifiers$xiM, s = modifiers$s, releaseType = "HH"))</a:t>
            </a:r>
          </a:p>
          <a:p>
            <a:pPr marL="0" marR="0"/>
            <a:r>
              <a:rPr lang="en-US" sz="1600" dirty="0">
                <a:ln>
                  <a:noFill/>
                </a:ln>
                <a:solidFill>
                  <a:srgbClr val="000000"/>
                </a:solidFill>
                <a:effectLst/>
                <a:ea typeface="Arial Unicode MS"/>
                <a:cs typeface="Arial Unicode MS"/>
              </a:rPr>
              <a:t>}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445779-2C1C-1ED6-86F5-F990679151F2}"/>
              </a:ext>
            </a:extLst>
          </p:cNvPr>
          <p:cNvSpPr txBox="1"/>
          <p:nvPr/>
        </p:nvSpPr>
        <p:spPr>
          <a:xfrm>
            <a:off x="874350" y="950161"/>
            <a:ext cx="41167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>
              <a:spcBef>
                <a:spcPts val="0"/>
              </a:spcBef>
              <a:spcAft>
                <a:spcPts val="0"/>
              </a:spcAft>
            </a:pPr>
            <a:r>
              <a:rPr lang="en-US" sz="4000" b="1" dirty="0"/>
              <a:t>S1 Text. </a:t>
            </a:r>
          </a:p>
        </p:txBody>
      </p:sp>
    </p:spTree>
    <p:extLst>
      <p:ext uri="{BB962C8B-B14F-4D97-AF65-F5344CB8AC3E}">
        <p14:creationId xmlns:p14="http://schemas.microsoft.com/office/powerpoint/2010/main" val="569847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2</TotalTime>
  <Words>1614</Words>
  <Application>Microsoft Office PowerPoint</Application>
  <PresentationFormat>Custom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Arial Unicode M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3</cp:revision>
  <dcterms:created xsi:type="dcterms:W3CDTF">2024-06-26T16:03:17Z</dcterms:created>
  <dcterms:modified xsi:type="dcterms:W3CDTF">2025-06-16T17:04:42Z</dcterms:modified>
</cp:coreProperties>
</file>